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DB&#12458;&#12540;&#12503;&#12531;&#12487;&#12540;&#12479;&#12398;&#20998;&#26512;\&#21407;&#31295;_%20&#21307;&#30274;&#36027;&#35036;&#21161;&#25919;&#31574;&#12392;&#12501;&#12483;&#21270;&#29289;&#27927;&#21475;\&#12464;&#12521;&#12501;&#20316;&#25104;&#29992;_bmcpb_revision_113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0199057662518482E-2"/>
          <c:y val="2.5622148687694801E-2"/>
          <c:w val="0.95067444891555508"/>
          <c:h val="0.8638203889211075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シーラント!$F$1:$F$2</c:f>
              <c:strCache>
                <c:ptCount val="2"/>
                <c:pt idx="1">
                  <c:v>201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シーラント!$E$3:$E$49</c:f>
              <c:numCache>
                <c:formatCode>General</c:formatCode>
                <c:ptCount val="4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シーラント!$F$3:$F$49</c:f>
              <c:numCache>
                <c:formatCode>General</c:formatCode>
                <c:ptCount val="47"/>
                <c:pt idx="0">
                  <c:v>110.08814801052947</c:v>
                </c:pt>
                <c:pt idx="1">
                  <c:v>76.924152625261968</c:v>
                </c:pt>
                <c:pt idx="2">
                  <c:v>73.898436568684772</c:v>
                </c:pt>
                <c:pt idx="3">
                  <c:v>86.427214717615911</c:v>
                </c:pt>
                <c:pt idx="4">
                  <c:v>82.778809105273126</c:v>
                </c:pt>
                <c:pt idx="5">
                  <c:v>111.30084907279172</c:v>
                </c:pt>
                <c:pt idx="6">
                  <c:v>68.14817990598084</c:v>
                </c:pt>
                <c:pt idx="7">
                  <c:v>80.58867681132466</c:v>
                </c:pt>
                <c:pt idx="8">
                  <c:v>78.630278352489242</c:v>
                </c:pt>
                <c:pt idx="9">
                  <c:v>87.062869577135956</c:v>
                </c:pt>
                <c:pt idx="10">
                  <c:v>71.934579953557133</c:v>
                </c:pt>
                <c:pt idx="11">
                  <c:v>99.363026134318432</c:v>
                </c:pt>
                <c:pt idx="12">
                  <c:v>98.529271643217783</c:v>
                </c:pt>
                <c:pt idx="13">
                  <c:v>95.387950378576491</c:v>
                </c:pt>
                <c:pt idx="14">
                  <c:v>74.229749137928209</c:v>
                </c:pt>
                <c:pt idx="15">
                  <c:v>160.28214951441913</c:v>
                </c:pt>
                <c:pt idx="16">
                  <c:v>32.484956446926333</c:v>
                </c:pt>
                <c:pt idx="17">
                  <c:v>17.392371016363864</c:v>
                </c:pt>
                <c:pt idx="18">
                  <c:v>58.950746495167607</c:v>
                </c:pt>
                <c:pt idx="19">
                  <c:v>29.538410276255579</c:v>
                </c:pt>
                <c:pt idx="20">
                  <c:v>187.12589580531346</c:v>
                </c:pt>
                <c:pt idx="21">
                  <c:v>133.00863521009944</c:v>
                </c:pt>
                <c:pt idx="22">
                  <c:v>210.03710085676198</c:v>
                </c:pt>
                <c:pt idx="23">
                  <c:v>57.05456689472441</c:v>
                </c:pt>
                <c:pt idx="24">
                  <c:v>56.405455629193376</c:v>
                </c:pt>
                <c:pt idx="25">
                  <c:v>87.964238194509775</c:v>
                </c:pt>
                <c:pt idx="26">
                  <c:v>116.68366698226464</c:v>
                </c:pt>
                <c:pt idx="27">
                  <c:v>78.075887109386429</c:v>
                </c:pt>
                <c:pt idx="28">
                  <c:v>94.388440950223597</c:v>
                </c:pt>
                <c:pt idx="29">
                  <c:v>88.403113215443312</c:v>
                </c:pt>
                <c:pt idx="30">
                  <c:v>80.461716403785658</c:v>
                </c:pt>
                <c:pt idx="31">
                  <c:v>57.967111922638381</c:v>
                </c:pt>
                <c:pt idx="32">
                  <c:v>148.30490310206488</c:v>
                </c:pt>
                <c:pt idx="33">
                  <c:v>58.538004840483246</c:v>
                </c:pt>
                <c:pt idx="34">
                  <c:v>58.720110309431085</c:v>
                </c:pt>
                <c:pt idx="35">
                  <c:v>110.28707469205821</c:v>
                </c:pt>
                <c:pt idx="36">
                  <c:v>72.71915314247687</c:v>
                </c:pt>
                <c:pt idx="37">
                  <c:v>82.909739829656374</c:v>
                </c:pt>
                <c:pt idx="38">
                  <c:v>105.44594369932203</c:v>
                </c:pt>
                <c:pt idx="39">
                  <c:v>124.92213310697646</c:v>
                </c:pt>
                <c:pt idx="40">
                  <c:v>65.991968448394275</c:v>
                </c:pt>
                <c:pt idx="41">
                  <c:v>120.55428678635298</c:v>
                </c:pt>
                <c:pt idx="42">
                  <c:v>89.843262305702197</c:v>
                </c:pt>
                <c:pt idx="43">
                  <c:v>61.620833378458649</c:v>
                </c:pt>
                <c:pt idx="44">
                  <c:v>93.331348628499683</c:v>
                </c:pt>
                <c:pt idx="45">
                  <c:v>78.89839059613611</c:v>
                </c:pt>
                <c:pt idx="46">
                  <c:v>60.4515047390308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03-4D81-98FE-E9E4E9051426}"/>
            </c:ext>
          </c:extLst>
        </c:ser>
        <c:ser>
          <c:idx val="1"/>
          <c:order val="1"/>
          <c:tx>
            <c:strRef>
              <c:f>シーラント!$G$1:$G$2</c:f>
              <c:strCache>
                <c:ptCount val="2"/>
                <c:pt idx="1">
                  <c:v>2018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シーラント!$E$3:$E$49</c:f>
              <c:numCache>
                <c:formatCode>General</c:formatCode>
                <c:ptCount val="4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</c:numCache>
            </c:numRef>
          </c:cat>
          <c:val>
            <c:numRef>
              <c:f>シーラント!$G$3:$G$49</c:f>
              <c:numCache>
                <c:formatCode>General</c:formatCode>
                <c:ptCount val="47"/>
                <c:pt idx="0">
                  <c:v>98.797212000000002</c:v>
                </c:pt>
                <c:pt idx="1">
                  <c:v>83.281737000000007</c:v>
                </c:pt>
                <c:pt idx="2">
                  <c:v>62.091808999999998</c:v>
                </c:pt>
                <c:pt idx="3">
                  <c:v>84.676644999999994</c:v>
                </c:pt>
                <c:pt idx="4">
                  <c:v>77.038687999999993</c:v>
                </c:pt>
                <c:pt idx="5">
                  <c:v>109.79143000000001</c:v>
                </c:pt>
                <c:pt idx="6">
                  <c:v>59.941687999999999</c:v>
                </c:pt>
                <c:pt idx="7">
                  <c:v>81.469843999999995</c:v>
                </c:pt>
                <c:pt idx="8">
                  <c:v>78.596374999999995</c:v>
                </c:pt>
                <c:pt idx="9">
                  <c:v>82.765281000000002</c:v>
                </c:pt>
                <c:pt idx="10">
                  <c:v>64.033680000000004</c:v>
                </c:pt>
                <c:pt idx="11">
                  <c:v>99.187318000000005</c:v>
                </c:pt>
                <c:pt idx="12">
                  <c:v>92.293880999999999</c:v>
                </c:pt>
                <c:pt idx="13">
                  <c:v>100.35664</c:v>
                </c:pt>
                <c:pt idx="14">
                  <c:v>64.544197999999994</c:v>
                </c:pt>
                <c:pt idx="15">
                  <c:v>165.42227</c:v>
                </c:pt>
                <c:pt idx="16">
                  <c:v>27.221311</c:v>
                </c:pt>
                <c:pt idx="17">
                  <c:v>27.117438</c:v>
                </c:pt>
                <c:pt idx="18">
                  <c:v>61.900042999999997</c:v>
                </c:pt>
                <c:pt idx="19">
                  <c:v>30.916022000000002</c:v>
                </c:pt>
                <c:pt idx="20">
                  <c:v>187.96235999999999</c:v>
                </c:pt>
                <c:pt idx="21">
                  <c:v>123.52977</c:v>
                </c:pt>
                <c:pt idx="22">
                  <c:v>230.36707999999999</c:v>
                </c:pt>
                <c:pt idx="23">
                  <c:v>47.365287000000002</c:v>
                </c:pt>
                <c:pt idx="24">
                  <c:v>53.590699000000001</c:v>
                </c:pt>
                <c:pt idx="25">
                  <c:v>86.227984000000006</c:v>
                </c:pt>
                <c:pt idx="26">
                  <c:v>121.69179</c:v>
                </c:pt>
                <c:pt idx="27">
                  <c:v>77.737530000000007</c:v>
                </c:pt>
                <c:pt idx="28">
                  <c:v>95.256992999999994</c:v>
                </c:pt>
                <c:pt idx="29">
                  <c:v>103.39028999999999</c:v>
                </c:pt>
                <c:pt idx="30">
                  <c:v>74.541892000000004</c:v>
                </c:pt>
                <c:pt idx="31">
                  <c:v>56.413006000000003</c:v>
                </c:pt>
                <c:pt idx="32">
                  <c:v>137.14388</c:v>
                </c:pt>
                <c:pt idx="33">
                  <c:v>59.371248000000001</c:v>
                </c:pt>
                <c:pt idx="34">
                  <c:v>56.969222000000002</c:v>
                </c:pt>
                <c:pt idx="35">
                  <c:v>109.5925</c:v>
                </c:pt>
                <c:pt idx="36">
                  <c:v>77.307886999999994</c:v>
                </c:pt>
                <c:pt idx="37">
                  <c:v>73.486677999999998</c:v>
                </c:pt>
                <c:pt idx="38">
                  <c:v>101.08328</c:v>
                </c:pt>
                <c:pt idx="39">
                  <c:v>137.00036</c:v>
                </c:pt>
                <c:pt idx="40">
                  <c:v>78.206599999999995</c:v>
                </c:pt>
                <c:pt idx="41">
                  <c:v>122.57802</c:v>
                </c:pt>
                <c:pt idx="42">
                  <c:v>95.622502999999995</c:v>
                </c:pt>
                <c:pt idx="43">
                  <c:v>61.434446999999999</c:v>
                </c:pt>
                <c:pt idx="44">
                  <c:v>86.830699999999993</c:v>
                </c:pt>
                <c:pt idx="45">
                  <c:v>71.051421000000005</c:v>
                </c:pt>
                <c:pt idx="46">
                  <c:v>59.362150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03-4D81-98FE-E9E4E90514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8109663"/>
        <c:axId val="908250175"/>
      </c:barChart>
      <c:catAx>
        <c:axId val="7581096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908250175"/>
        <c:crosses val="autoZero"/>
        <c:auto val="1"/>
        <c:lblAlgn val="ctr"/>
        <c:lblOffset val="100"/>
        <c:noMultiLvlLbl val="0"/>
      </c:catAx>
      <c:valAx>
        <c:axId val="908250175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5810966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3730938957204393"/>
          <c:y val="0.22917139586870605"/>
          <c:w val="0.14040204214444765"/>
          <c:h val="5.11852878247998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3DC77-A271-59F5-D55A-34C37773D8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27E775-A75E-72C3-8B29-D00DB28C30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3334CE-66D1-01BC-0892-9FDC7756E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F20D4A-A2B7-4470-09C6-6E85CF6E8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D0B358-E515-6038-8FE4-CEE486746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79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6F22B9-3D77-2A8E-3B09-6786753F0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10BF24-9BE9-32E4-7A83-A0DC2398B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99C77-A68E-BBA4-6FAE-7EB6DB5F7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E6ECA1-0675-CEA1-77A3-B6B183A1B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217A69-7625-BA8D-A570-B257F8D6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53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05D4B15-19F5-1B26-7E9A-BFCFB6EE4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776D627-F637-0A82-C18D-0CAA2B9F9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212BFC-389F-91B6-5510-932A6B27A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F69F6F-956E-B0C0-4E41-0B3D70EF4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9DA32D-9D7A-7090-5B44-486932F20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360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4A640D-60D2-0DAB-326C-DAD962557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33413-7D16-8BD1-159F-5783A08AE8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9B6378-0983-38D7-C3F3-391E54065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360BA4-C8B4-E86D-DDBA-C96EAF3CC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5B040C-451A-3FDC-9815-78C46D36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74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812DA3-EAC7-0466-D0A7-74726EDDD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8063543-00C5-F06C-F901-5F4736FF8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0C0D54-E11D-2100-1082-390CCB3A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928D9F-4A3F-A193-0356-3A7FFD0CC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8EDF2B-B3F8-7088-D440-177F6F00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35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E370C3-7288-E156-4CDA-CD12C7B7C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9AC83A-CCD3-CF9B-0842-9FA65EA0DD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2069E7-CE31-B14E-8F15-725348EE9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FF16AE-8A3E-46D7-ACD5-60223AAA5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0D6DD9-DFA9-DB84-AD1D-6D81E16B2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0F7F54-6ABD-98FB-EBEE-BBAB12978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184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70DA7C-2594-6C9F-015A-D96E96EA4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07476A-37D1-F63A-B228-1803DD9C1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329D0D-3C75-C050-9AA8-046501921D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396B8A3-F18B-FA21-3E7F-55B7CE264E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5F0172-07E9-1BD1-4BE6-274DF4C468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A39993C-D8A7-86A7-419D-8CC9B9B90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920688-ABFA-3F8E-4ECA-27A58870F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B328E0D-17D3-AA06-0F66-9FA3D9AB3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512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E4B0CF-A5B3-0B82-2CEC-39CDF3062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65D74F-64C2-A671-482B-553D8D371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484A4E-E892-278F-9ABA-B3B7D642E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D527508-3A04-46BC-638E-1CF59DEB1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62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D4C87BA-3A7F-83B6-2763-7F44FCE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BF0517-E863-0C9E-AD5A-97E1DEB5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E4E00F-1C47-9276-6B92-1112BD169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990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253E4-B1B1-3DB8-F98E-67A83577D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3D5132-A9BE-D52F-5E9A-44869C6CFA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E9A37D-6D13-4556-5993-EFD57CF2A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E6028F-C45A-C768-F3DF-1A3EBCE3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257CB5-2ED2-E0FF-A6D9-11B1DEE2C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16789D-CD1A-4DE9-5261-9B76E5A4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45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DCE48B-160C-A889-6685-7D50FCE3F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D3D4F2-8379-7544-D556-9158BA6C16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BE937E-A323-8E2F-91B8-6B6A2197C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343373-95E2-E9CA-DE03-BDF23F65B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194E29-7F03-0BF8-973F-56C22C696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16E4EE-F028-D2C6-7702-24616E674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97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E57FFD-B15E-6F48-E2AA-38710242D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D1A6F5-FCEB-53E1-DA29-F7D97EA11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3D23F2-F598-4B43-7FAD-03E8CE714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3A2A1F-FDBB-B79D-0684-734F8655BF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495D6E-2C5B-2860-08A9-652075FE37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74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37389BD-4698-EB23-0250-4DB6A54B55A9}"/>
              </a:ext>
            </a:extLst>
          </p:cNvPr>
          <p:cNvSpPr txBox="1"/>
          <p:nvPr/>
        </p:nvSpPr>
        <p:spPr>
          <a:xfrm>
            <a:off x="5529178" y="5364469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fectur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C5BABC9-630C-BF5A-7A8E-B23AC7ECF07D}"/>
              </a:ext>
            </a:extLst>
          </p:cNvPr>
          <p:cNvSpPr txBox="1"/>
          <p:nvPr/>
        </p:nvSpPr>
        <p:spPr>
          <a:xfrm>
            <a:off x="733425" y="5659258"/>
            <a:ext cx="10725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; standard claim ratio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3923B83-0867-ED70-647D-F3862EC952AE}"/>
              </a:ext>
            </a:extLst>
          </p:cNvPr>
          <p:cNvSpPr txBox="1"/>
          <p:nvPr/>
        </p:nvSpPr>
        <p:spPr>
          <a:xfrm>
            <a:off x="200414" y="2842697"/>
            <a:ext cx="7329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</a:t>
            </a:r>
            <a:endParaRPr lang="ja-JP" altLang="en-US" dirty="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5CAC98C-D026-AF1E-14D0-9D501AF4B802}"/>
              </a:ext>
            </a:extLst>
          </p:cNvPr>
          <p:cNvGraphicFramePr>
            <a:graphicFrameLocks/>
          </p:cNvGraphicFramePr>
          <p:nvPr/>
        </p:nvGraphicFramePr>
        <p:xfrm>
          <a:off x="733425" y="0"/>
          <a:ext cx="10966962" cy="55491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EFB99EDC-A87A-41DA-35B6-DBB01FD0A404}"/>
              </a:ext>
            </a:extLst>
          </p:cNvPr>
          <p:cNvCxnSpPr>
            <a:cxnSpLocks/>
          </p:cNvCxnSpPr>
          <p:nvPr/>
        </p:nvCxnSpPr>
        <p:spPr>
          <a:xfrm>
            <a:off x="1133269" y="47133"/>
            <a:ext cx="18853" cy="491654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EE362E1-2E56-2652-4668-B989AA1C817E}"/>
              </a:ext>
            </a:extLst>
          </p:cNvPr>
          <p:cNvCxnSpPr>
            <a:cxnSpLocks/>
          </p:cNvCxnSpPr>
          <p:nvPr/>
        </p:nvCxnSpPr>
        <p:spPr>
          <a:xfrm flipH="1">
            <a:off x="1140643" y="4944826"/>
            <a:ext cx="10679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328F991-5172-B226-CF6D-64740E76DE00}"/>
              </a:ext>
            </a:extLst>
          </p:cNvPr>
          <p:cNvSpPr txBox="1"/>
          <p:nvPr/>
        </p:nvSpPr>
        <p:spPr>
          <a:xfrm>
            <a:off x="331695" y="6177180"/>
            <a:ext cx="115148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The SCR of dental sealant trend among prefectures in Japan between 2016 to 2018</a:t>
            </a:r>
            <a:endParaRPr lang="ja-JP" altLang="en-US" sz="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legends: A figure shows the SCR of dental sealant trends in each prefecture between 2016 and 2018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983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貴文</dc:creator>
  <cp:lastModifiedBy>takafumi yamamoto</cp:lastModifiedBy>
  <cp:revision>6</cp:revision>
  <dcterms:created xsi:type="dcterms:W3CDTF">2023-12-07T06:34:18Z</dcterms:created>
  <dcterms:modified xsi:type="dcterms:W3CDTF">2024-02-12T23:19:42Z</dcterms:modified>
</cp:coreProperties>
</file>